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152" d="100"/>
          <a:sy n="152" d="100"/>
        </p:scale>
        <p:origin x="652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verage Percentage Membership 2019-2023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4.6875000000000068E-3"/>
                  <c:y val="-2.3437498558224958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C26-481D-933F-3D3F8DB05B8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3</c:f>
              <c:strCache>
                <c:ptCount val="12"/>
                <c:pt idx="0">
                  <c:v>American</c:v>
                </c:pt>
                <c:pt idx="1">
                  <c:v>Australian-New Zealand</c:v>
                </c:pt>
                <c:pt idx="2">
                  <c:v>Continental European</c:v>
                </c:pt>
                <c:pt idx="3">
                  <c:v>British</c:v>
                </c:pt>
                <c:pt idx="4">
                  <c:v>Scandinavian</c:v>
                </c:pt>
                <c:pt idx="5">
                  <c:v>Japanese</c:v>
                </c:pt>
                <c:pt idx="6">
                  <c:v>Chinese</c:v>
                </c:pt>
                <c:pt idx="7">
                  <c:v>Brazilian</c:v>
                </c:pt>
                <c:pt idx="8">
                  <c:v>Canadian</c:v>
                </c:pt>
                <c:pt idx="9">
                  <c:v>Irish</c:v>
                </c:pt>
                <c:pt idx="10">
                  <c:v>Israeli</c:v>
                </c:pt>
                <c:pt idx="11">
                  <c:v>South-East Asian</c:v>
                </c:pt>
              </c:strCache>
            </c:strRef>
          </c:cat>
          <c:val>
            <c:numRef>
              <c:f>Sheet1!$B$2:$B$13</c:f>
              <c:numCache>
                <c:formatCode>General</c:formatCode>
                <c:ptCount val="12"/>
                <c:pt idx="0">
                  <c:v>32.799999999999997</c:v>
                </c:pt>
                <c:pt idx="1">
                  <c:v>3.2</c:v>
                </c:pt>
                <c:pt idx="2">
                  <c:v>9.1</c:v>
                </c:pt>
                <c:pt idx="3">
                  <c:v>4.5999999999999996</c:v>
                </c:pt>
                <c:pt idx="4">
                  <c:v>2.4</c:v>
                </c:pt>
                <c:pt idx="5">
                  <c:v>9.9</c:v>
                </c:pt>
                <c:pt idx="6">
                  <c:v>9.6999999999999993</c:v>
                </c:pt>
                <c:pt idx="7">
                  <c:v>3.3</c:v>
                </c:pt>
                <c:pt idx="8">
                  <c:v>2.8</c:v>
                </c:pt>
                <c:pt idx="9">
                  <c:v>0.7</c:v>
                </c:pt>
                <c:pt idx="10">
                  <c:v>1.5</c:v>
                </c:pt>
                <c:pt idx="11">
                  <c:v>4.40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26-481D-933F-3D3F8DB05B8C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ercentage DSA awardees 2019-2024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3</c:f>
              <c:strCache>
                <c:ptCount val="12"/>
                <c:pt idx="0">
                  <c:v>American</c:v>
                </c:pt>
                <c:pt idx="1">
                  <c:v>Australian-New Zealand</c:v>
                </c:pt>
                <c:pt idx="2">
                  <c:v>Continental European</c:v>
                </c:pt>
                <c:pt idx="3">
                  <c:v>British</c:v>
                </c:pt>
                <c:pt idx="4">
                  <c:v>Scandinavian</c:v>
                </c:pt>
                <c:pt idx="5">
                  <c:v>Japanese</c:v>
                </c:pt>
                <c:pt idx="6">
                  <c:v>Chinese</c:v>
                </c:pt>
                <c:pt idx="7">
                  <c:v>Brazilian</c:v>
                </c:pt>
                <c:pt idx="8">
                  <c:v>Canadian</c:v>
                </c:pt>
                <c:pt idx="9">
                  <c:v>Irish</c:v>
                </c:pt>
                <c:pt idx="10">
                  <c:v>Israeli</c:v>
                </c:pt>
                <c:pt idx="11">
                  <c:v>South-East Asian</c:v>
                </c:pt>
              </c:strCache>
            </c:strRef>
          </c:cat>
          <c:val>
            <c:numRef>
              <c:f>Sheet1!$C$2:$C$13</c:f>
              <c:numCache>
                <c:formatCode>General</c:formatCode>
                <c:ptCount val="12"/>
                <c:pt idx="0">
                  <c:v>38.4</c:v>
                </c:pt>
                <c:pt idx="1">
                  <c:v>14.1</c:v>
                </c:pt>
                <c:pt idx="2">
                  <c:v>13.1</c:v>
                </c:pt>
                <c:pt idx="3">
                  <c:v>12.1</c:v>
                </c:pt>
                <c:pt idx="4">
                  <c:v>7.1</c:v>
                </c:pt>
                <c:pt idx="5">
                  <c:v>5.0999999999999996</c:v>
                </c:pt>
                <c:pt idx="6">
                  <c:v>3</c:v>
                </c:pt>
                <c:pt idx="7">
                  <c:v>2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26-481D-933F-3D3F8DB05B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89479247"/>
        <c:axId val="1089474447"/>
      </c:barChart>
      <c:catAx>
        <c:axId val="10894792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089474447"/>
        <c:crosses val="autoZero"/>
        <c:auto val="1"/>
        <c:lblAlgn val="ctr"/>
        <c:lblOffset val="100"/>
        <c:noMultiLvlLbl val="0"/>
      </c:catAx>
      <c:valAx>
        <c:axId val="108947444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AU" sz="1200" baseline="0" dirty="0">
                    <a:solidFill>
                      <a:schemeClr val="tx1"/>
                    </a:solidFill>
                    <a:latin typeface="Arial" panose="020B0604020202020204" pitchFamily="34" charset="0"/>
                  </a:rPr>
                  <a:t>Percent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0894792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AB038-3638-43EA-DDC3-F1DDC77F76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34411A-7FB7-E45B-5DF1-9992B19368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1D12F-E363-9972-D868-EB8957F08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DB53BF-E5AC-2B18-FD79-60298EA22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2A0582-7828-0F1F-A706-4169CB753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5837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2B9629-D06C-B6C5-C5CC-497D89ABC0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85E915-7D75-03DD-695A-E4A7887DF3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0B5021-E582-581E-B017-68FFF8226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34699F-D266-8FB1-090B-9378D0709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F21F23-8549-D594-E52E-F123F0C1C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672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05B1AC-3901-685D-325C-7A075E3B28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2E84D2-1B96-C6E4-04D7-238E998EB3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0B5E83-B38B-1FCD-E90C-359F74F3B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EA528D-A003-043C-66AE-C11BCDDD7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B22D37-D9A0-8CB8-B4A8-ADDB48560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9557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E1C903-19FE-808C-D5EE-D263B5BB00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3BE3AA-EFA4-ED59-3FEB-CC9E747613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795DE1-051A-917F-56B2-53A63AED8A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9A7E93-FA1B-25EE-305C-48791E287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780AFE-4D1F-6457-55CD-4C5D6D8F3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6784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FCB21-FEC5-7699-E2F1-E6FEFC52E2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22A418-DA36-47AE-D5CC-E8A63BB9C6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6A7202-A2F1-A34B-9509-A6E88FD02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CD9634-8CCA-9A60-787B-F582976F16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7AA4DA-B0C3-301D-1C6A-89125799F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3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B9BCE3-3330-2AF9-E4BC-52B7F1920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4D17A2-B7FB-35C3-049A-68F5BF0A2F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E77A9E-00F9-251E-7B61-95F99FA6C3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AAE7E1-E0AF-82E1-A13C-2B8F82368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DF0869-6F38-225E-B79E-A3134ED0A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33247E-EF30-CECE-7626-EAC166EF1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6146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74E5F-7E02-55BA-F47D-17C922D72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C819BF-2446-9079-D680-88DA69820A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849141-BCD8-84C4-700B-EE288E9608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208B08-5242-CF86-FAB0-4E1916D01B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52A876-2B75-72E6-B5AD-DEBC7302C8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7CF6C1-92B5-8CAA-9789-968D76623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45C09A-1D56-EB0B-E7D6-2577242C0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80A741-881A-DB1A-F470-6A2C288FE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5131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F5A40A-C478-0E94-5EF6-251088A34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B4CDB5-A277-0806-50F2-6BF989E29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3B3FF76-322A-ABC6-CC1A-5D01D3CF1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3522B0-3E58-94CF-9784-D5509B6F2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6662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0905D7-2304-AAD0-03B5-353B1E8C5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A19FB5-9CD9-7EA8-66EC-43110C9BA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E20E39-B7D7-60A1-0602-DC7874241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0944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DE30BB-DF9A-A5B6-098A-8023FF5738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EA04F8-36F6-8BB7-8287-319092B42C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04750F-AF70-7D26-866F-EC30D6594D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EAD822-75C4-1148-A533-A8ED4823E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E3FD8B-54C2-1999-D4E7-BB95C8680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B42B77-9744-A5F1-2509-C92EDF9D2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6086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51E337-3F41-39F6-C21F-85D4B6EA8B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EB3125-8FC7-887C-D3D5-5D67506253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3ED0C1-A27C-664A-FC69-E1529E0CC8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714543-3947-F515-95D1-6EEFE7E05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517407-0EA6-7477-4CD5-C995165BF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3A22FE-BEFD-BFB3-F887-6A5A47578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84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556E0A-5952-A47D-3961-DF6781CE6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5DFC52-3D62-5EEA-E258-7159FE79EF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33B22-1A71-FB81-7DAD-462DE79153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F8B4C-1913-48DC-9E49-9439A9D829DE}" type="datetimeFigureOut">
              <a:rPr lang="en-AU" smtClean="0"/>
              <a:t>12/08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21CCBC-F650-53A3-FCE0-53ED0962DA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344B85-784B-E0BE-A5EB-D8F5164711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BB1F8-5A8B-4A38-B120-6F8986F3844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24313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CBF5E3D-5AE2-AB31-D192-5EA89D991C5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33673830"/>
              </p:ext>
            </p:extLst>
          </p:nvPr>
        </p:nvGraphicFramePr>
        <p:xfrm>
          <a:off x="2032000" y="719666"/>
          <a:ext cx="8128000" cy="5418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9C59773-4FA8-1D32-21AB-1585558C9226}"/>
              </a:ext>
            </a:extLst>
          </p:cNvPr>
          <p:cNvSpPr txBox="1"/>
          <p:nvPr/>
        </p:nvSpPr>
        <p:spPr>
          <a:xfrm>
            <a:off x="2438399" y="6427893"/>
            <a:ext cx="75929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1.</a:t>
            </a:r>
            <a:r>
              <a:rPr lang="en-AU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mparison of the distribution of Division membership (2019-2023) and DSA awardees 2019-2024.</a:t>
            </a:r>
          </a:p>
        </p:txBody>
      </p:sp>
    </p:spTree>
    <p:extLst>
      <p:ext uri="{BB962C8B-B14F-4D97-AF65-F5344CB8AC3E}">
        <p14:creationId xmlns:p14="http://schemas.microsoft.com/office/powerpoint/2010/main" val="3677826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tilal Lalloo</dc:creator>
  <cp:lastModifiedBy>Ratilal Lalloo</cp:lastModifiedBy>
  <cp:revision>3</cp:revision>
  <dcterms:created xsi:type="dcterms:W3CDTF">2024-05-02T23:09:01Z</dcterms:created>
  <dcterms:modified xsi:type="dcterms:W3CDTF">2024-08-11T23:50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f488380-630a-4f55-a077-a19445e3f360_Enabled">
    <vt:lpwstr>true</vt:lpwstr>
  </property>
  <property fmtid="{D5CDD505-2E9C-101B-9397-08002B2CF9AE}" pid="3" name="MSIP_Label_0f488380-630a-4f55-a077-a19445e3f360_SetDate">
    <vt:lpwstr>2024-05-02T23:17:08Z</vt:lpwstr>
  </property>
  <property fmtid="{D5CDD505-2E9C-101B-9397-08002B2CF9AE}" pid="4" name="MSIP_Label_0f488380-630a-4f55-a077-a19445e3f360_Method">
    <vt:lpwstr>Standard</vt:lpwstr>
  </property>
  <property fmtid="{D5CDD505-2E9C-101B-9397-08002B2CF9AE}" pid="5" name="MSIP_Label_0f488380-630a-4f55-a077-a19445e3f360_Name">
    <vt:lpwstr>OFFICIAL - INTERNAL</vt:lpwstr>
  </property>
  <property fmtid="{D5CDD505-2E9C-101B-9397-08002B2CF9AE}" pid="6" name="MSIP_Label_0f488380-630a-4f55-a077-a19445e3f360_SiteId">
    <vt:lpwstr>b6e377cf-9db3-46cb-91a2-fad9605bb15c</vt:lpwstr>
  </property>
  <property fmtid="{D5CDD505-2E9C-101B-9397-08002B2CF9AE}" pid="7" name="MSIP_Label_0f488380-630a-4f55-a077-a19445e3f360_ActionId">
    <vt:lpwstr>6e097c3e-9f05-4ef8-b205-dfc2a6489e61</vt:lpwstr>
  </property>
  <property fmtid="{D5CDD505-2E9C-101B-9397-08002B2CF9AE}" pid="8" name="MSIP_Label_0f488380-630a-4f55-a077-a19445e3f360_ContentBits">
    <vt:lpwstr>0</vt:lpwstr>
  </property>
</Properties>
</file>